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40" r:id="rId1"/>
  </p:sldMasterIdLst>
  <p:sldIdLst>
    <p:sldId id="259" r:id="rId2"/>
  </p:sldIdLst>
  <p:sldSz cx="6303963" cy="7559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3B99E"/>
    <a:srgbClr val="F08961"/>
    <a:srgbClr val="F4B183"/>
    <a:srgbClr val="F8CBAD"/>
    <a:srgbClr val="DAE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770" autoAdjust="0"/>
    <p:restoredTop sz="94660"/>
  </p:normalViewPr>
  <p:slideViewPr>
    <p:cSldViewPr snapToGrid="0">
      <p:cViewPr>
        <p:scale>
          <a:sx n="66" d="100"/>
          <a:sy n="66" d="100"/>
        </p:scale>
        <p:origin x="3450" y="8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797" y="1237197"/>
            <a:ext cx="5358369" cy="2631887"/>
          </a:xfrm>
        </p:spPr>
        <p:txBody>
          <a:bodyPr anchor="b"/>
          <a:lstStyle>
            <a:lvl1pPr algn="ctr">
              <a:defRPr sz="41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996" y="3970580"/>
            <a:ext cx="4727972" cy="1825171"/>
          </a:xfrm>
        </p:spPr>
        <p:txBody>
          <a:bodyPr/>
          <a:lstStyle>
            <a:lvl1pPr marL="0" indent="0" algn="ctr">
              <a:buNone/>
              <a:defRPr sz="1655"/>
            </a:lvl1pPr>
            <a:lvl2pPr marL="315194" indent="0" algn="ctr">
              <a:buNone/>
              <a:defRPr sz="1379"/>
            </a:lvl2pPr>
            <a:lvl3pPr marL="630387" indent="0" algn="ctr">
              <a:buNone/>
              <a:defRPr sz="1241"/>
            </a:lvl3pPr>
            <a:lvl4pPr marL="945581" indent="0" algn="ctr">
              <a:buNone/>
              <a:defRPr sz="1103"/>
            </a:lvl4pPr>
            <a:lvl5pPr marL="1260775" indent="0" algn="ctr">
              <a:buNone/>
              <a:defRPr sz="1103"/>
            </a:lvl5pPr>
            <a:lvl6pPr marL="1575968" indent="0" algn="ctr">
              <a:buNone/>
              <a:defRPr sz="1103"/>
            </a:lvl6pPr>
            <a:lvl7pPr marL="1891162" indent="0" algn="ctr">
              <a:buNone/>
              <a:defRPr sz="1103"/>
            </a:lvl7pPr>
            <a:lvl8pPr marL="2206356" indent="0" algn="ctr">
              <a:buNone/>
              <a:defRPr sz="1103"/>
            </a:lvl8pPr>
            <a:lvl9pPr marL="2521549" indent="0" algn="ctr">
              <a:buNone/>
              <a:defRPr sz="110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72499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43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11274" y="402483"/>
            <a:ext cx="1359292" cy="64064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398" y="402483"/>
            <a:ext cx="3999077" cy="640647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0193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7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115" y="1884671"/>
            <a:ext cx="5437168" cy="3144614"/>
          </a:xfrm>
        </p:spPr>
        <p:txBody>
          <a:bodyPr anchor="b"/>
          <a:lstStyle>
            <a:lvl1pPr>
              <a:defRPr sz="413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115" y="5059035"/>
            <a:ext cx="5437168" cy="1653678"/>
          </a:xfrm>
        </p:spPr>
        <p:txBody>
          <a:bodyPr/>
          <a:lstStyle>
            <a:lvl1pPr marL="0" indent="0">
              <a:buNone/>
              <a:defRPr sz="1655">
                <a:solidFill>
                  <a:schemeClr val="tx1"/>
                </a:solidFill>
              </a:defRPr>
            </a:lvl1pPr>
            <a:lvl2pPr marL="315194" indent="0">
              <a:buNone/>
              <a:defRPr sz="1379">
                <a:solidFill>
                  <a:schemeClr val="tx1">
                    <a:tint val="75000"/>
                  </a:schemeClr>
                </a:solidFill>
              </a:defRPr>
            </a:lvl2pPr>
            <a:lvl3pPr marL="630387" indent="0">
              <a:buNone/>
              <a:defRPr sz="1241">
                <a:solidFill>
                  <a:schemeClr val="tx1">
                    <a:tint val="75000"/>
                  </a:schemeClr>
                </a:solidFill>
              </a:defRPr>
            </a:lvl3pPr>
            <a:lvl4pPr marL="945581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775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968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116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635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154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9458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398" y="2012414"/>
            <a:ext cx="2679184" cy="479654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91381" y="2012414"/>
            <a:ext cx="2679184" cy="479654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8384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219" y="402484"/>
            <a:ext cx="5437168" cy="14611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219" y="1853171"/>
            <a:ext cx="2666871" cy="908210"/>
          </a:xfrm>
        </p:spPr>
        <p:txBody>
          <a:bodyPr anchor="b"/>
          <a:lstStyle>
            <a:lvl1pPr marL="0" indent="0">
              <a:buNone/>
              <a:defRPr sz="1655" b="1"/>
            </a:lvl1pPr>
            <a:lvl2pPr marL="315194" indent="0">
              <a:buNone/>
              <a:defRPr sz="1379" b="1"/>
            </a:lvl2pPr>
            <a:lvl3pPr marL="630387" indent="0">
              <a:buNone/>
              <a:defRPr sz="1241" b="1"/>
            </a:lvl3pPr>
            <a:lvl4pPr marL="945581" indent="0">
              <a:buNone/>
              <a:defRPr sz="1103" b="1"/>
            </a:lvl4pPr>
            <a:lvl5pPr marL="1260775" indent="0">
              <a:buNone/>
              <a:defRPr sz="1103" b="1"/>
            </a:lvl5pPr>
            <a:lvl6pPr marL="1575968" indent="0">
              <a:buNone/>
              <a:defRPr sz="1103" b="1"/>
            </a:lvl6pPr>
            <a:lvl7pPr marL="1891162" indent="0">
              <a:buNone/>
              <a:defRPr sz="1103" b="1"/>
            </a:lvl7pPr>
            <a:lvl8pPr marL="2206356" indent="0">
              <a:buNone/>
              <a:defRPr sz="1103" b="1"/>
            </a:lvl8pPr>
            <a:lvl9pPr marL="2521549" indent="0">
              <a:buNone/>
              <a:defRPr sz="110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219" y="2761381"/>
            <a:ext cx="2666871" cy="40615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91382" y="1853171"/>
            <a:ext cx="2680005" cy="908210"/>
          </a:xfrm>
        </p:spPr>
        <p:txBody>
          <a:bodyPr anchor="b"/>
          <a:lstStyle>
            <a:lvl1pPr marL="0" indent="0">
              <a:buNone/>
              <a:defRPr sz="1655" b="1"/>
            </a:lvl1pPr>
            <a:lvl2pPr marL="315194" indent="0">
              <a:buNone/>
              <a:defRPr sz="1379" b="1"/>
            </a:lvl2pPr>
            <a:lvl3pPr marL="630387" indent="0">
              <a:buNone/>
              <a:defRPr sz="1241" b="1"/>
            </a:lvl3pPr>
            <a:lvl4pPr marL="945581" indent="0">
              <a:buNone/>
              <a:defRPr sz="1103" b="1"/>
            </a:lvl4pPr>
            <a:lvl5pPr marL="1260775" indent="0">
              <a:buNone/>
              <a:defRPr sz="1103" b="1"/>
            </a:lvl5pPr>
            <a:lvl6pPr marL="1575968" indent="0">
              <a:buNone/>
              <a:defRPr sz="1103" b="1"/>
            </a:lvl6pPr>
            <a:lvl7pPr marL="1891162" indent="0">
              <a:buNone/>
              <a:defRPr sz="1103" b="1"/>
            </a:lvl7pPr>
            <a:lvl8pPr marL="2206356" indent="0">
              <a:buNone/>
              <a:defRPr sz="1103" b="1"/>
            </a:lvl8pPr>
            <a:lvl9pPr marL="2521549" indent="0">
              <a:buNone/>
              <a:defRPr sz="110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91382" y="2761381"/>
            <a:ext cx="2680005" cy="406157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9390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8190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8983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219" y="503978"/>
            <a:ext cx="2033192" cy="1763924"/>
          </a:xfrm>
        </p:spPr>
        <p:txBody>
          <a:bodyPr anchor="b"/>
          <a:lstStyle>
            <a:lvl1pPr>
              <a:defRPr sz="220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0005" y="1088455"/>
            <a:ext cx="3191381" cy="5372269"/>
          </a:xfrm>
        </p:spPr>
        <p:txBody>
          <a:bodyPr/>
          <a:lstStyle>
            <a:lvl1pPr>
              <a:defRPr sz="2206"/>
            </a:lvl1pPr>
            <a:lvl2pPr>
              <a:defRPr sz="1930"/>
            </a:lvl2pPr>
            <a:lvl3pPr>
              <a:defRPr sz="1655"/>
            </a:lvl3pPr>
            <a:lvl4pPr>
              <a:defRPr sz="1379"/>
            </a:lvl4pPr>
            <a:lvl5pPr>
              <a:defRPr sz="1379"/>
            </a:lvl5pPr>
            <a:lvl6pPr>
              <a:defRPr sz="1379"/>
            </a:lvl6pPr>
            <a:lvl7pPr>
              <a:defRPr sz="1379"/>
            </a:lvl7pPr>
            <a:lvl8pPr>
              <a:defRPr sz="1379"/>
            </a:lvl8pPr>
            <a:lvl9pPr>
              <a:defRPr sz="137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219" y="2267902"/>
            <a:ext cx="2033192" cy="4201570"/>
          </a:xfrm>
        </p:spPr>
        <p:txBody>
          <a:bodyPr/>
          <a:lstStyle>
            <a:lvl1pPr marL="0" indent="0">
              <a:buNone/>
              <a:defRPr sz="1103"/>
            </a:lvl1pPr>
            <a:lvl2pPr marL="315194" indent="0">
              <a:buNone/>
              <a:defRPr sz="965"/>
            </a:lvl2pPr>
            <a:lvl3pPr marL="630387" indent="0">
              <a:buNone/>
              <a:defRPr sz="827"/>
            </a:lvl3pPr>
            <a:lvl4pPr marL="945581" indent="0">
              <a:buNone/>
              <a:defRPr sz="689"/>
            </a:lvl4pPr>
            <a:lvl5pPr marL="1260775" indent="0">
              <a:buNone/>
              <a:defRPr sz="689"/>
            </a:lvl5pPr>
            <a:lvl6pPr marL="1575968" indent="0">
              <a:buNone/>
              <a:defRPr sz="689"/>
            </a:lvl6pPr>
            <a:lvl7pPr marL="1891162" indent="0">
              <a:buNone/>
              <a:defRPr sz="689"/>
            </a:lvl7pPr>
            <a:lvl8pPr marL="2206356" indent="0">
              <a:buNone/>
              <a:defRPr sz="689"/>
            </a:lvl8pPr>
            <a:lvl9pPr marL="2521549" indent="0">
              <a:buNone/>
              <a:defRPr sz="68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078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219" y="503978"/>
            <a:ext cx="2033192" cy="1763924"/>
          </a:xfrm>
        </p:spPr>
        <p:txBody>
          <a:bodyPr anchor="b"/>
          <a:lstStyle>
            <a:lvl1pPr>
              <a:defRPr sz="220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80005" y="1088455"/>
            <a:ext cx="3191381" cy="5372269"/>
          </a:xfrm>
        </p:spPr>
        <p:txBody>
          <a:bodyPr anchor="t"/>
          <a:lstStyle>
            <a:lvl1pPr marL="0" indent="0">
              <a:buNone/>
              <a:defRPr sz="2206"/>
            </a:lvl1pPr>
            <a:lvl2pPr marL="315194" indent="0">
              <a:buNone/>
              <a:defRPr sz="1930"/>
            </a:lvl2pPr>
            <a:lvl3pPr marL="630387" indent="0">
              <a:buNone/>
              <a:defRPr sz="1655"/>
            </a:lvl3pPr>
            <a:lvl4pPr marL="945581" indent="0">
              <a:buNone/>
              <a:defRPr sz="1379"/>
            </a:lvl4pPr>
            <a:lvl5pPr marL="1260775" indent="0">
              <a:buNone/>
              <a:defRPr sz="1379"/>
            </a:lvl5pPr>
            <a:lvl6pPr marL="1575968" indent="0">
              <a:buNone/>
              <a:defRPr sz="1379"/>
            </a:lvl6pPr>
            <a:lvl7pPr marL="1891162" indent="0">
              <a:buNone/>
              <a:defRPr sz="1379"/>
            </a:lvl7pPr>
            <a:lvl8pPr marL="2206356" indent="0">
              <a:buNone/>
              <a:defRPr sz="1379"/>
            </a:lvl8pPr>
            <a:lvl9pPr marL="2521549" indent="0">
              <a:buNone/>
              <a:defRPr sz="137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219" y="2267902"/>
            <a:ext cx="2033192" cy="4201570"/>
          </a:xfrm>
        </p:spPr>
        <p:txBody>
          <a:bodyPr/>
          <a:lstStyle>
            <a:lvl1pPr marL="0" indent="0">
              <a:buNone/>
              <a:defRPr sz="1103"/>
            </a:lvl1pPr>
            <a:lvl2pPr marL="315194" indent="0">
              <a:buNone/>
              <a:defRPr sz="965"/>
            </a:lvl2pPr>
            <a:lvl3pPr marL="630387" indent="0">
              <a:buNone/>
              <a:defRPr sz="827"/>
            </a:lvl3pPr>
            <a:lvl4pPr marL="945581" indent="0">
              <a:buNone/>
              <a:defRPr sz="689"/>
            </a:lvl4pPr>
            <a:lvl5pPr marL="1260775" indent="0">
              <a:buNone/>
              <a:defRPr sz="689"/>
            </a:lvl5pPr>
            <a:lvl6pPr marL="1575968" indent="0">
              <a:buNone/>
              <a:defRPr sz="689"/>
            </a:lvl6pPr>
            <a:lvl7pPr marL="1891162" indent="0">
              <a:buNone/>
              <a:defRPr sz="689"/>
            </a:lvl7pPr>
            <a:lvl8pPr marL="2206356" indent="0">
              <a:buNone/>
              <a:defRPr sz="689"/>
            </a:lvl8pPr>
            <a:lvl9pPr marL="2521549" indent="0">
              <a:buNone/>
              <a:defRPr sz="689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2545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398" y="402484"/>
            <a:ext cx="5437168" cy="1461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398" y="2012414"/>
            <a:ext cx="5437168" cy="479654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397" y="7006700"/>
            <a:ext cx="1418392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8188" y="7006700"/>
            <a:ext cx="2127588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52174" y="7006700"/>
            <a:ext cx="1418392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0576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630387" rtl="0" eaLnBrk="1" latinLnBrk="0" hangingPunct="1">
        <a:lnSpc>
          <a:spcPct val="90000"/>
        </a:lnSpc>
        <a:spcBef>
          <a:spcPct val="0"/>
        </a:spcBef>
        <a:buNone/>
        <a:defRPr sz="303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97" indent="-157597" algn="l" defTabSz="630387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30" kern="1200">
          <a:solidFill>
            <a:schemeClr val="tx1"/>
          </a:solidFill>
          <a:latin typeface="+mn-lt"/>
          <a:ea typeface="+mn-ea"/>
          <a:cs typeface="+mn-cs"/>
        </a:defRPr>
      </a:lvl1pPr>
      <a:lvl2pPr marL="472791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2pPr>
      <a:lvl3pPr marL="787984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9" kern="1200">
          <a:solidFill>
            <a:schemeClr val="tx1"/>
          </a:solidFill>
          <a:latin typeface="+mn-lt"/>
          <a:ea typeface="+mn-ea"/>
          <a:cs typeface="+mn-cs"/>
        </a:defRPr>
      </a:lvl3pPr>
      <a:lvl4pPr marL="1103178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4pPr>
      <a:lvl5pPr marL="1418372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5pPr>
      <a:lvl6pPr marL="1733565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6pPr>
      <a:lvl7pPr marL="2048759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7pPr>
      <a:lvl8pPr marL="2363953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8pPr>
      <a:lvl9pPr marL="2679146" indent="-157597" algn="l" defTabSz="630387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1pPr>
      <a:lvl2pPr marL="315194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2pPr>
      <a:lvl3pPr marL="630387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3pPr>
      <a:lvl4pPr marL="945581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4pPr>
      <a:lvl5pPr marL="1260775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5pPr>
      <a:lvl6pPr marL="1575968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6pPr>
      <a:lvl7pPr marL="1891162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7pPr>
      <a:lvl8pPr marL="2206356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8pPr>
      <a:lvl9pPr marL="2521549" algn="l" defTabSz="630387" rtl="0" eaLnBrk="1" latinLnBrk="0" hangingPunct="1">
        <a:defRPr sz="124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8264692F-78E7-44DE-800E-D3B2DE2C4F21}"/>
              </a:ext>
            </a:extLst>
          </p:cNvPr>
          <p:cNvGrpSpPr/>
          <p:nvPr/>
        </p:nvGrpSpPr>
        <p:grpSpPr>
          <a:xfrm>
            <a:off x="641026" y="971693"/>
            <a:ext cx="5021906" cy="6107766"/>
            <a:chOff x="658943" y="369856"/>
            <a:chExt cx="5162282" cy="6278494"/>
          </a:xfrm>
        </p:grpSpPr>
        <p:sp>
          <p:nvSpPr>
            <p:cNvPr id="4" name="矩形: 圆角 3">
              <a:extLst>
                <a:ext uri="{FF2B5EF4-FFF2-40B4-BE49-F238E27FC236}">
                  <a16:creationId xmlns:a16="http://schemas.microsoft.com/office/drawing/2014/main" id="{3F1522BF-AA4B-4CDF-9D05-1AFD2AA1A7F8}"/>
                </a:ext>
              </a:extLst>
            </p:cNvPr>
            <p:cNvSpPr/>
            <p:nvPr/>
          </p:nvSpPr>
          <p:spPr>
            <a:xfrm>
              <a:off x="658949" y="369856"/>
              <a:ext cx="5162276" cy="449318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ll input genes  </a:t>
              </a:r>
              <a:endParaRPr lang="zh-CN" altLang="en-US" sz="127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矩形: 圆角 4">
              <a:extLst>
                <a:ext uri="{FF2B5EF4-FFF2-40B4-BE49-F238E27FC236}">
                  <a16:creationId xmlns:a16="http://schemas.microsoft.com/office/drawing/2014/main" id="{E410E76C-B886-433A-9BB1-DCE991B994CF}"/>
                </a:ext>
              </a:extLst>
            </p:cNvPr>
            <p:cNvSpPr/>
            <p:nvPr/>
          </p:nvSpPr>
          <p:spPr>
            <a:xfrm>
              <a:off x="658947" y="1429227"/>
              <a:ext cx="5162276" cy="854026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ove mitochondrial genes</a:t>
              </a:r>
            </a:p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move ribosomal genes</a:t>
              </a:r>
              <a:endParaRPr lang="zh-CN" altLang="en-US" sz="127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6" name="矩形: 圆角 5">
                  <a:extLst>
                    <a:ext uri="{FF2B5EF4-FFF2-40B4-BE49-F238E27FC236}">
                      <a16:creationId xmlns:a16="http://schemas.microsoft.com/office/drawing/2014/main" id="{AEC47C7A-46EE-4380-8FD5-94705CE6E750}"/>
                    </a:ext>
                  </a:extLst>
                </p:cNvPr>
                <p:cNvSpPr/>
                <p:nvPr/>
              </p:nvSpPr>
              <p:spPr>
                <a:xfrm>
                  <a:off x="658943" y="2817106"/>
                  <a:ext cx="5162277" cy="1152739"/>
                </a:xfrm>
                <a:prstGeom prst="roundRect">
                  <a:avLst/>
                </a:prstGeom>
                <a:noFill/>
                <a:ln w="190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algn="ctr"/>
                  <a:r>
                    <a:rPr lang="en-US" altLang="zh-CN" sz="1273" b="1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move genes without significant between MSI and MSS samples</a:t>
                  </a:r>
                </a:p>
                <a:p>
                  <a:pPr algn="ctr"/>
                  <a:r>
                    <a:rPr lang="en-US" altLang="zh-CN" sz="1273" dirty="0" err="1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anksum</a:t>
                  </a:r>
                  <a:r>
                    <a:rPr lang="en-US" altLang="zh-CN" sz="1273" dirty="0">
                      <a:solidFill>
                        <a:schemeClr val="tx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14:m>
                    <m:oMath xmlns:m="http://schemas.openxmlformats.org/officeDocument/2006/math">
                      <m:r>
                        <m:rPr>
                          <m:nor/>
                        </m:rPr>
                        <a:rPr lang="en-US" altLang="zh-CN" sz="1273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P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 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value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 </m:t>
                      </m:r>
                      <m:r>
                        <a:rPr lang="en-US" altLang="zh-CN" sz="1273" i="1" dirty="0">
                          <a:solidFill>
                            <a:schemeClr val="tx1"/>
                          </a:solidFill>
                          <a:latin typeface="Cambria Math" panose="02040503050406030204" pitchFamily="18" charset="0"/>
                          <a:ea typeface="Cambria Math" panose="02040503050406030204" pitchFamily="18" charset="0"/>
                          <a:cs typeface="Times New Roman" panose="02020603050405020304" pitchFamily="18" charset="0"/>
                        </a:rPr>
                        <m:t>≥</m:t>
                      </m:r>
                      <m:r>
                        <m:rPr>
                          <m:nor/>
                        </m:rPr>
                        <a:rPr lang="en-US" altLang="zh-CN" sz="1273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m:t>0.01 </m:t>
                      </m:r>
                    </m:oMath>
                  </a14:m>
                  <a:endParaRPr lang="en-US" altLang="zh-CN" sz="1273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14:m>
                    <m:oMathPara xmlns:m="http://schemas.openxmlformats.org/officeDocument/2006/math">
                      <m:oMathParaPr>
                        <m:jc m:val="centerGroup"/>
                      </m:oMathParaPr>
                      <m:oMath xmlns:m="http://schemas.openxmlformats.org/officeDocument/2006/math">
                        <m:d>
                          <m:dPr>
                            <m:begChr m:val="|"/>
                            <m:endChr m:val="|"/>
                            <m:ctrlPr>
                              <a:rPr lang="en-US" altLang="zh-CN" sz="1273" i="1" dirty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</m:ctrlPr>
                          </m:dPr>
                          <m:e>
                            <m:r>
                              <m:rPr>
                                <m:nor/>
                              </m:rPr>
                              <a:rPr lang="en-US" altLang="zh-CN" sz="1273" dirty="0">
                                <a:solidFill>
                                  <a:schemeClr val="tx1"/>
                                </a:solidFill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m:t>Fold</m:t>
                            </m:r>
                          </m:e>
                        </m:d>
                        <m:r>
                          <a:rPr lang="en-US" altLang="zh-CN" sz="1273" i="1" dirty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cs typeface="Times New Roman" panose="02020603050405020304" pitchFamily="18" charset="0"/>
                          </a:rPr>
                          <m:t>=</m:t>
                        </m:r>
                        <m:d>
                          <m:dPr>
                            <m:begChr m:val="|"/>
                            <m:endChr m:val="|"/>
                            <m:ctrlPr>
                              <a:rPr lang="en-US" altLang="zh-CN" sz="1273" i="1" dirty="0">
                                <a:solidFill>
                                  <a:schemeClr val="tx1"/>
                                </a:solidFill>
                                <a:latin typeface="Cambria Math" panose="02040503050406030204" pitchFamily="18" charset="0"/>
                                <a:cs typeface="Times New Roman" panose="02020603050405020304" pitchFamily="18" charset="0"/>
                              </a:rPr>
                            </m:ctrlPr>
                          </m:dPr>
                          <m:e>
                            <m:sSub>
                              <m:sSubPr>
                                <m:ctrlPr>
                                  <a:rPr lang="en-US" altLang="zh-CN" sz="1273" i="1" dirty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</m:ctrlPr>
                              </m:sSubPr>
                              <m:e>
                                <m:r>
                                  <a:rPr lang="en-US" altLang="zh-CN" sz="1273" i="1" dirty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𝑙𝑜𝑔</m:t>
                                </m:r>
                              </m:e>
                              <m:sub>
                                <m:r>
                                  <a:rPr lang="en-US" altLang="zh-CN" sz="1273" i="1" dirty="0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Arial" panose="020B0604020202020204" pitchFamily="34" charset="0"/>
                                  </a:rPr>
                                  <m:t>2</m:t>
                                </m:r>
                              </m:sub>
                            </m:sSub>
                            <m:d>
                              <m:dPr>
                                <m:ctrlPr>
                                  <a:rPr lang="en-US" altLang="zh-CN" sz="1273" i="1">
                                    <a:solidFill>
                                      <a:schemeClr val="tx1"/>
                                    </a:solidFill>
                                    <a:latin typeface="Cambria Math" panose="02040503050406030204" pitchFamily="18" charset="0"/>
                                    <a:cs typeface="Times New Roman" panose="02020603050405020304" pitchFamily="18" charset="0"/>
                                  </a:rPr>
                                </m:ctrlPr>
                              </m:dPr>
                              <m:e>
                                <m:f>
                                  <m:fPr>
                                    <m:ctrlPr>
                                      <a:rPr lang="en-US" altLang="zh-CN" sz="1273" i="1">
                                        <a:solidFill>
                                          <a:schemeClr val="tx1"/>
                                        </a:solidFill>
                                        <a:latin typeface="Cambria Math" panose="02040503050406030204" pitchFamily="18" charset="0"/>
                                      </a:rPr>
                                    </m:ctrlPr>
                                  </m:fPr>
                                  <m:num>
                                    <m:r>
                                      <m:rPr>
                                        <m:nor/>
                                      </m:rPr>
                                      <a:rPr lang="en-US" altLang="zh-CN" sz="1273" dirty="0"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m:t>mean</m:t>
                                    </m:r>
                                    <m:d>
                                      <m:dPr>
                                        <m:ctrlPr>
                                          <a:rPr lang="en-US" altLang="zh-CN" sz="1273" i="1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</a:rPr>
                                        </m:ctrlPr>
                                      </m:dPr>
                                      <m:e>
                                        <m:r>
                                          <m:rPr>
                                            <m:sty m:val="p"/>
                                          </m:rPr>
                                          <a:rPr lang="en-US" altLang="zh-CN" sz="1273" i="1" dirty="0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  <a:cs typeface="Times New Roman" panose="02020603050405020304" pitchFamily="18" charset="0"/>
                                          </a:rPr>
                                          <m:t>MSI</m:t>
                                        </m:r>
                                      </m:e>
                                    </m:d>
                                  </m:num>
                                  <m:den>
                                    <m:r>
                                      <m:rPr>
                                        <m:nor/>
                                      </m:rPr>
                                      <a:rPr lang="en-US" altLang="zh-CN" sz="1273" dirty="0">
                                        <a:solidFill>
                                          <a:schemeClr val="tx1"/>
                                        </a:solidFill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m:t>mean</m:t>
                                    </m:r>
                                    <m:d>
                                      <m:dPr>
                                        <m:ctrlPr>
                                          <a:rPr lang="en-US" altLang="zh-CN" sz="1273" i="1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</a:rPr>
                                        </m:ctrlPr>
                                      </m:dPr>
                                      <m:e>
                                        <m:r>
                                          <m:rPr>
                                            <m:sty m:val="p"/>
                                          </m:rPr>
                                          <a:rPr lang="en-US" altLang="zh-CN" sz="1273">
                                            <a:solidFill>
                                              <a:schemeClr val="tx1"/>
                                            </a:solidFill>
                                            <a:latin typeface="Cambria Math" panose="02040503050406030204" pitchFamily="18" charset="0"/>
                                          </a:rPr>
                                          <m:t>MSS</m:t>
                                        </m:r>
                                      </m:e>
                                    </m:d>
                                  </m:den>
                                </m:f>
                              </m:e>
                            </m:d>
                          </m:e>
                        </m:d>
                        <m:r>
                          <a:rPr lang="en-US" altLang="zh-CN" sz="1273" i="1" dirty="0">
                            <a:solidFill>
                              <a:schemeClr val="tx1"/>
                            </a:solidFill>
                            <a:latin typeface="Cambria Math" panose="02040503050406030204" pitchFamily="18" charset="0"/>
                            <a:ea typeface="Cambria Math" panose="02040503050406030204" pitchFamily="18" charset="0"/>
                            <a:cs typeface="Times New Roman" panose="02020603050405020304" pitchFamily="18" charset="0"/>
                          </a:rPr>
                          <m:t>≤0.5</m:t>
                        </m:r>
                      </m:oMath>
                    </m:oMathPara>
                  </a14:m>
                  <a:endParaRPr lang="zh-CN" altLang="en-US" sz="1273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6" name="矩形: 圆角 5">
                  <a:extLst>
                    <a:ext uri="{FF2B5EF4-FFF2-40B4-BE49-F238E27FC236}">
                      <a16:creationId xmlns:a16="http://schemas.microsoft.com/office/drawing/2014/main" id="{AEC47C7A-46EE-4380-8FD5-94705CE6E750}"/>
                    </a:ext>
                  </a:extLst>
                </p:cNvPr>
                <p:cNvSpPr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>
                  <a:off x="658943" y="2817106"/>
                  <a:ext cx="5162277" cy="1152739"/>
                </a:xfrm>
                <a:prstGeom prst="roundRect">
                  <a:avLst/>
                </a:prstGeom>
                <a:blipFill>
                  <a:blip r:embed="rId2"/>
                  <a:stretch>
                    <a:fillRect/>
                  </a:stretch>
                </a:blipFill>
                <a:ln w="19050"/>
              </p:spPr>
              <p:txBody>
                <a:bodyPr/>
                <a:lstStyle/>
                <a:p>
                  <a:r>
                    <a:rPr 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5BA5B65B-5F98-4E33-9A94-D1F2A1555DA3}"/>
                </a:ext>
              </a:extLst>
            </p:cNvPr>
            <p:cNvSpPr/>
            <p:nvPr/>
          </p:nvSpPr>
          <p:spPr>
            <a:xfrm>
              <a:off x="658945" y="4512282"/>
              <a:ext cx="5162276" cy="970824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eep genes with high classified score</a:t>
              </a:r>
            </a:p>
            <a:p>
              <a:pPr algn="ctr"/>
              <a:r>
                <a:rPr lang="en-US" altLang="zh-CN" sz="1273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UC &gt; 0.65</a:t>
              </a:r>
            </a:p>
            <a:p>
              <a:pPr algn="ctr"/>
              <a:r>
                <a:rPr lang="en-US" altLang="zh-CN" sz="1273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op 25% cross validation score of SVM </a:t>
              </a:r>
            </a:p>
            <a:p>
              <a:pPr algn="ctr"/>
              <a:r>
                <a:rPr lang="en-US" altLang="zh-CN" sz="1273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p 25% cross validation score of random forest </a:t>
              </a:r>
            </a:p>
          </p:txBody>
        </p:sp>
        <p:sp>
          <p:nvSpPr>
            <p:cNvPr id="9" name="矩形: 圆角 8">
              <a:extLst>
                <a:ext uri="{FF2B5EF4-FFF2-40B4-BE49-F238E27FC236}">
                  <a16:creationId xmlns:a16="http://schemas.microsoft.com/office/drawing/2014/main" id="{74F6A5FB-6674-4281-B7E4-F12C0D9678A5}"/>
                </a:ext>
              </a:extLst>
            </p:cNvPr>
            <p:cNvSpPr/>
            <p:nvPr/>
          </p:nvSpPr>
          <p:spPr>
            <a:xfrm>
              <a:off x="658945" y="6093158"/>
              <a:ext cx="5162276" cy="555192"/>
            </a:xfrm>
            <a:prstGeom prst="roundRect">
              <a:avLst/>
            </a:prstGeom>
            <a:noFill/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29411" tIns="64705" rIns="129411" bIns="6470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1273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ormative genes  </a:t>
              </a:r>
              <a:endParaRPr lang="zh-CN" altLang="en-US" sz="1273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箭头: 下 9">
              <a:extLst>
                <a:ext uri="{FF2B5EF4-FFF2-40B4-BE49-F238E27FC236}">
                  <a16:creationId xmlns:a16="http://schemas.microsoft.com/office/drawing/2014/main" id="{B2994D96-6BE2-4B8A-B175-9EE14F78D732}"/>
                </a:ext>
              </a:extLst>
            </p:cNvPr>
            <p:cNvSpPr/>
            <p:nvPr/>
          </p:nvSpPr>
          <p:spPr>
            <a:xfrm>
              <a:off x="3105695" y="885765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箭头: 下 10">
              <a:extLst>
                <a:ext uri="{FF2B5EF4-FFF2-40B4-BE49-F238E27FC236}">
                  <a16:creationId xmlns:a16="http://schemas.microsoft.com/office/drawing/2014/main" id="{9C7157D1-743F-4833-89A9-3D5DD5BEF9D0}"/>
                </a:ext>
              </a:extLst>
            </p:cNvPr>
            <p:cNvSpPr/>
            <p:nvPr/>
          </p:nvSpPr>
          <p:spPr>
            <a:xfrm>
              <a:off x="3105695" y="2349844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箭头: 下 11">
              <a:extLst>
                <a:ext uri="{FF2B5EF4-FFF2-40B4-BE49-F238E27FC236}">
                  <a16:creationId xmlns:a16="http://schemas.microsoft.com/office/drawing/2014/main" id="{3BA60A27-9716-4EC9-8D3E-D9F3A83C03CD}"/>
                </a:ext>
              </a:extLst>
            </p:cNvPr>
            <p:cNvSpPr/>
            <p:nvPr/>
          </p:nvSpPr>
          <p:spPr>
            <a:xfrm>
              <a:off x="3105695" y="4016445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箭头: 下 12">
              <a:extLst>
                <a:ext uri="{FF2B5EF4-FFF2-40B4-BE49-F238E27FC236}">
                  <a16:creationId xmlns:a16="http://schemas.microsoft.com/office/drawing/2014/main" id="{12487194-7D26-4F15-8CA3-7634C265FDB5}"/>
                </a:ext>
              </a:extLst>
            </p:cNvPr>
            <p:cNvSpPr/>
            <p:nvPr/>
          </p:nvSpPr>
          <p:spPr>
            <a:xfrm>
              <a:off x="3105695" y="5568747"/>
              <a:ext cx="150106" cy="438771"/>
            </a:xfrm>
            <a:prstGeom prst="downArrow">
              <a:avLst/>
            </a:prstGeom>
            <a:ln w="190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61750" tIns="80876" rIns="161750" bIns="8087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6049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232B8EC2-D77D-4E03-9864-F5D19E3590C1}"/>
                </a:ext>
              </a:extLst>
            </p:cNvPr>
            <p:cNvSpPr txBox="1"/>
            <p:nvPr/>
          </p:nvSpPr>
          <p:spPr>
            <a:xfrm>
              <a:off x="3326859" y="972098"/>
              <a:ext cx="835770" cy="310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62" dirty="0">
                  <a:latin typeface="Arial" panose="020B0604020202020204" pitchFamily="34" charset="0"/>
                  <a:cs typeface="Arial" panose="020B0604020202020204" pitchFamily="34" charset="0"/>
                </a:rPr>
                <a:t>stability </a:t>
              </a:r>
              <a:endParaRPr lang="zh-CN" altLang="en-US" sz="136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F256D2BD-EE33-4D38-9FB9-A2C29B2A42E7}"/>
                </a:ext>
              </a:extLst>
            </p:cNvPr>
            <p:cNvSpPr txBox="1"/>
            <p:nvPr/>
          </p:nvSpPr>
          <p:spPr>
            <a:xfrm>
              <a:off x="3326859" y="2375037"/>
              <a:ext cx="1287270" cy="310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62" dirty="0">
                  <a:latin typeface="Arial" panose="020B0604020202020204" pitchFamily="34" charset="0"/>
                  <a:cs typeface="Arial" panose="020B0604020202020204" pitchFamily="34" charset="0"/>
                </a:rPr>
                <a:t>discrimination</a:t>
              </a:r>
              <a:endParaRPr lang="zh-CN" altLang="en-US" sz="136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1C8F7325-1AE9-40C8-973F-2E55BABFAE50}"/>
                </a:ext>
              </a:extLst>
            </p:cNvPr>
            <p:cNvSpPr txBox="1"/>
            <p:nvPr/>
          </p:nvSpPr>
          <p:spPr>
            <a:xfrm>
              <a:off x="3326859" y="4047654"/>
              <a:ext cx="1310340" cy="3103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362" dirty="0">
                  <a:latin typeface="Arial" panose="020B0604020202020204" pitchFamily="34" charset="0"/>
                  <a:cs typeface="Arial" panose="020B0604020202020204" pitchFamily="34" charset="0"/>
                </a:rPr>
                <a:t>generalization</a:t>
              </a:r>
              <a:endParaRPr lang="zh-CN" altLang="en-US" sz="1362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60819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9</TotalTime>
  <Words>60</Words>
  <Application>Microsoft Office PowerPoint</Application>
  <PresentationFormat>自定义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Arial</vt:lpstr>
      <vt:lpstr>Calibri</vt:lpstr>
      <vt:lpstr>Calibri Light</vt:lpstr>
      <vt:lpstr>Cambria Math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orkflow</dc:title>
  <dc:creator>peng Jia</dc:creator>
  <cp:lastModifiedBy>PENG JIA</cp:lastModifiedBy>
  <cp:revision>51</cp:revision>
  <dcterms:created xsi:type="dcterms:W3CDTF">2021-12-09T03:34:22Z</dcterms:created>
  <dcterms:modified xsi:type="dcterms:W3CDTF">2023-10-17T14:57:39Z</dcterms:modified>
</cp:coreProperties>
</file>